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1" autoAdjust="0"/>
    <p:restoredTop sz="94660"/>
  </p:normalViewPr>
  <p:slideViewPr>
    <p:cSldViewPr snapToGrid="0">
      <p:cViewPr varScale="1">
        <p:scale>
          <a:sx n="45" d="100"/>
          <a:sy n="45" d="100"/>
        </p:scale>
        <p:origin x="24" y="9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F29B3-4947-4700-A0FE-63688403C1C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205E0-0E1A-41D2-89B2-62D485180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08276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F29B3-4947-4700-A0FE-63688403C1C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205E0-0E1A-41D2-89B2-62D485180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14942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F29B3-4947-4700-A0FE-63688403C1C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205E0-0E1A-41D2-89B2-62D485180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61879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F29B3-4947-4700-A0FE-63688403C1C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205E0-0E1A-41D2-89B2-62D485180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22821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F29B3-4947-4700-A0FE-63688403C1C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205E0-0E1A-41D2-89B2-62D485180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12795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F29B3-4947-4700-A0FE-63688403C1C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205E0-0E1A-41D2-89B2-62D485180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43918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F29B3-4947-4700-A0FE-63688403C1C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205E0-0E1A-41D2-89B2-62D485180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30091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F29B3-4947-4700-A0FE-63688403C1C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205E0-0E1A-41D2-89B2-62D485180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58343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F29B3-4947-4700-A0FE-63688403C1C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205E0-0E1A-41D2-89B2-62D485180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8050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F29B3-4947-4700-A0FE-63688403C1C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205E0-0E1A-41D2-89B2-62D485180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67244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F29B3-4947-4700-A0FE-63688403C1C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205E0-0E1A-41D2-89B2-62D485180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10111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9F29B3-4947-4700-A0FE-63688403C1C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3205E0-0E1A-41D2-89B2-62D485180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83379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66949" y="566057"/>
            <a:ext cx="9039679" cy="5168628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Rectangle 1"/>
          <p:cNvSpPr>
            <a:spLocks noChangeArrowheads="1"/>
          </p:cNvSpPr>
          <p:nvPr/>
        </p:nvSpPr>
        <p:spPr bwMode="auto">
          <a:xfrm>
            <a:off x="948267" y="5960533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Figure S17.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Correlation between β-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haematin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inhibition activity (BIHA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, µM) and 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anti-malarial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activity (IC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­, nM) for reversed chloroquinolines against resistant strain Dd2</a:t>
            </a: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rPr>
              <a:t> 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193685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MS Mincho</vt:lpstr>
      <vt:lpstr>Times New Roman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goc Nguyen</dc:creator>
  <cp:lastModifiedBy>Ngoc Nguyen</cp:lastModifiedBy>
  <cp:revision>2</cp:revision>
  <dcterms:created xsi:type="dcterms:W3CDTF">2020-07-03T16:09:29Z</dcterms:created>
  <dcterms:modified xsi:type="dcterms:W3CDTF">2020-08-04T16:34:26Z</dcterms:modified>
</cp:coreProperties>
</file>